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A1EA21-57E5-4AF5-9BBF-DB0B237C04D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0832AA-2EE6-4589-84F1-DDFBE084A86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E00E10-CFCB-472A-8FDA-E2F7B9B8174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E6A2A5-9D5B-4001-9834-A8125365268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788D96-89E3-4B7F-A263-ABE696AEFD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CF4CD9-90D4-4729-B811-B253DCF6C6B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64C1F0-BFA6-417A-8826-9A304CD577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113A22-C51F-4B98-A1F8-A5E56B70A2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6575D1-364D-42FA-B93B-3E29DC8FF9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5502F2-68FC-43B2-82E0-F4E66A4644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AA8668-E708-4A24-ADF9-C33472B2D5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F1A753-B316-4750-B8FB-21432B83E2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34E6479-A727-4FCF-B9DE-C1A9B6B926D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0" t="0" r="0" b="9522"/>
          <a:stretch/>
        </p:blipFill>
        <p:spPr>
          <a:xfrm>
            <a:off x="0" y="803160"/>
            <a:ext cx="9109080" cy="615492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42" name=""/>
          <p:cNvSpPr/>
          <p:nvPr/>
        </p:nvSpPr>
        <p:spPr>
          <a:xfrm>
            <a:off x="0" y="0"/>
            <a:ext cx="18432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0" y="0"/>
            <a:ext cx="34308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0" y="6480"/>
            <a:ext cx="9144000" cy="79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Arial"/>
              </a:rPr>
              <a:t>Additional Figure 1 :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</a:rPr>
              <a:t> In </a:t>
            </a:r>
            <a:r>
              <a:rPr b="0" i="1" lang="en-AU" sz="1200" spc="-1" strike="noStrike">
                <a:solidFill>
                  <a:srgbClr val="000000"/>
                </a:solidFill>
                <a:latin typeface="Arial"/>
              </a:rPr>
              <a:t>silico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</a:rPr>
              <a:t> analysis of expressed sequence tags (EST) from Trichostrongylus vitrinus (Nematoda): comparison of the automated ESTExplorer workflow platform with database searche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</a:rPr>
              <a:t>Shivashankar H. Nagaraj, Robin B. Gasser, Alasdair J. Nisbet and Shoba Ranganathan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AU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AU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AU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AU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AU" sz="1000" spc="-1" strike="noStrike">
                <a:solidFill>
                  <a:srgbClr val="000000"/>
                </a:solidFill>
                <a:latin typeface="Arial"/>
              </a:rPr>
              <a:t>	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5-22T06:11:51Z</dcterms:created>
  <dc:creator>shiv</dc:creator>
  <dc:description/>
  <dc:language>en-US</dc:language>
  <cp:lastModifiedBy>shiv</cp:lastModifiedBy>
  <dcterms:modified xsi:type="dcterms:W3CDTF">2007-08-24T03:21:49Z</dcterms:modified>
  <cp:revision>3</cp:revision>
  <dc:subject/>
  <dc:title>Slide 1</dc:title>
</cp:coreProperties>
</file>